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9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0" y="-15875"/>
            <a:ext cx="238252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lang="en-US" altLang="zh-CN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379095" y="0"/>
            <a:ext cx="11433810" cy="6326505"/>
            <a:chOff x="547" y="797"/>
            <a:chExt cx="18006" cy="9963"/>
          </a:xfrm>
        </p:grpSpPr>
        <p:grpSp>
          <p:nvGrpSpPr>
            <p:cNvPr id="9" name="组合 8"/>
            <p:cNvGrpSpPr/>
            <p:nvPr/>
          </p:nvGrpSpPr>
          <p:grpSpPr>
            <a:xfrm>
              <a:off x="547" y="1561"/>
              <a:ext cx="10437" cy="7897"/>
              <a:chOff x="0" y="797"/>
              <a:chExt cx="13426" cy="9790"/>
            </a:xfrm>
          </p:grpSpPr>
          <p:pic>
            <p:nvPicPr>
              <p:cNvPr id="4" name="图片 3" descr="图片1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0" y="797"/>
                <a:ext cx="13426" cy="9791"/>
              </a:xfrm>
              <a:prstGeom prst="rect">
                <a:avLst/>
              </a:prstGeom>
            </p:spPr>
          </p:pic>
          <p:grpSp>
            <p:nvGrpSpPr>
              <p:cNvPr id="8" name="组合 7"/>
              <p:cNvGrpSpPr/>
              <p:nvPr/>
            </p:nvGrpSpPr>
            <p:grpSpPr>
              <a:xfrm>
                <a:off x="1958" y="1913"/>
                <a:ext cx="11468" cy="6367"/>
                <a:chOff x="1958" y="1913"/>
                <a:chExt cx="11468" cy="6367"/>
              </a:xfrm>
            </p:grpSpPr>
            <p:sp>
              <p:nvSpPr>
                <p:cNvPr id="2" name="矩形 1"/>
                <p:cNvSpPr/>
                <p:nvPr/>
              </p:nvSpPr>
              <p:spPr>
                <a:xfrm>
                  <a:off x="1958" y="1913"/>
                  <a:ext cx="11468" cy="54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" name="矩形 2"/>
                <p:cNvSpPr/>
                <p:nvPr/>
              </p:nvSpPr>
              <p:spPr>
                <a:xfrm>
                  <a:off x="1958" y="7740"/>
                  <a:ext cx="6615" cy="54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10" name="文本框 9"/>
            <p:cNvSpPr txBox="1"/>
            <p:nvPr/>
          </p:nvSpPr>
          <p:spPr>
            <a:xfrm>
              <a:off x="4828" y="797"/>
              <a:ext cx="362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ncropped figure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4173" y="2011"/>
              <a:ext cx="295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ropped figure 3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021" y="3004"/>
              <a:ext cx="6533" cy="2126"/>
            </a:xfrm>
            <a:prstGeom prst="rect">
              <a:avLst/>
            </a:prstGeom>
          </p:spPr>
        </p:pic>
        <p:grpSp>
          <p:nvGrpSpPr>
            <p:cNvPr id="13" name="组合 12"/>
            <p:cNvGrpSpPr/>
            <p:nvPr/>
          </p:nvGrpSpPr>
          <p:grpSpPr>
            <a:xfrm>
              <a:off x="11671" y="6660"/>
              <a:ext cx="6793" cy="3391"/>
              <a:chOff x="342" y="1557"/>
              <a:chExt cx="10287" cy="8230"/>
            </a:xfrm>
          </p:grpSpPr>
          <p:pic>
            <p:nvPicPr>
              <p:cNvPr id="14" name="图片 13" descr="图片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2" y="1557"/>
                <a:ext cx="10287" cy="8230"/>
              </a:xfrm>
              <a:prstGeom prst="rect">
                <a:avLst/>
              </a:prstGeom>
            </p:spPr>
          </p:pic>
          <p:sp>
            <p:nvSpPr>
              <p:cNvPr id="15" name="矩形 14"/>
              <p:cNvSpPr/>
              <p:nvPr/>
            </p:nvSpPr>
            <p:spPr>
              <a:xfrm>
                <a:off x="5333" y="3375"/>
                <a:ext cx="5297" cy="119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>
                  <a:ln>
                    <a:solidFill>
                      <a:srgbClr val="FF0000"/>
                    </a:solidFill>
                  </a:ln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6" name="文本框 15"/>
            <p:cNvSpPr txBox="1"/>
            <p:nvPr/>
          </p:nvSpPr>
          <p:spPr>
            <a:xfrm>
              <a:off x="14836" y="10180"/>
              <a:ext cx="362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ncropped figure</a:t>
              </a:r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右箭头 16"/>
            <p:cNvSpPr/>
            <p:nvPr/>
          </p:nvSpPr>
          <p:spPr>
            <a:xfrm>
              <a:off x="11109" y="4116"/>
              <a:ext cx="902" cy="119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8" name="上箭头 17"/>
            <p:cNvSpPr/>
            <p:nvPr/>
          </p:nvSpPr>
          <p:spPr>
            <a:xfrm>
              <a:off x="17101" y="5425"/>
              <a:ext cx="119" cy="1131"/>
            </a:xfrm>
            <a:prstGeom prst="up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358775" y="6326505"/>
            <a:ext cx="77806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Fig.S2.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 Full-length gels of Fig.3 are presented in supplementary Fig. S2.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WPS 演示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等线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自定义</dc:creator>
  <cp:lastModifiedBy>自定义</cp:lastModifiedBy>
  <cp:revision>15</cp:revision>
  <dcterms:created xsi:type="dcterms:W3CDTF">2021-05-19T00:04:00Z</dcterms:created>
  <dcterms:modified xsi:type="dcterms:W3CDTF">2021-10-27T00:55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0FD78142AE140BC8A562A04FA9FFB76</vt:lpwstr>
  </property>
  <property fmtid="{D5CDD505-2E9C-101B-9397-08002B2CF9AE}" pid="3" name="KSOProductBuildVer">
    <vt:lpwstr>2052-11.1.0.10938</vt:lpwstr>
  </property>
</Properties>
</file>